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7B1F91-9CDE-4208-9A19-61C990ED68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BE7AA-0B6D-4E5E-927E-5A47B27DCC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747DE-CE6A-4AFA-A9DA-46A255B436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CF8ED-A2B6-4351-B68F-2444FA88AF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5D613-E879-4EF9-B09E-00FE5C47A1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55BBA5-5243-4220-B850-58183EB661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68AB9-00BB-4C16-AB85-BE0DEA9900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8FA16-EEEF-423B-A830-C2B3AC5C04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5C51D-B4B6-447D-BB07-DD524AD268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68D97-F2A4-490A-96B7-34CD542E27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9DC5D-5B50-45BF-9866-B6E78835A0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67D10-E7BE-434A-ABC7-52D09A69D9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C4CED4-C9F3-4A71-BF99-5F1154EA867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58920" y="198360"/>
            <a:ext cx="10404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Unsupervised variable clustering to evaluate correlations between variables associated with primary outcomes among medical students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image4.png" descr="A picture containing text, screenshot, diagram, pattern&#10;&#10;Description automatically generated"/>
          <p:cNvPicPr/>
          <p:nvPr/>
        </p:nvPicPr>
        <p:blipFill>
          <a:blip r:embed="rId1"/>
          <a:stretch/>
        </p:blipFill>
        <p:spPr>
          <a:xfrm>
            <a:off x="3336840" y="550800"/>
            <a:ext cx="6931080" cy="6307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5-30T19:36:09Z</dcterms:created>
  <dc:creator>Omar Toubat</dc:creator>
  <dc:description/>
  <dc:language>en-US</dc:language>
  <cp:lastModifiedBy>Toubat, Omar</cp:lastModifiedBy>
  <dcterms:modified xsi:type="dcterms:W3CDTF">2024-04-16T20:02:44Z</dcterms:modified>
  <cp:revision>51</cp:revision>
  <dc:subject/>
  <dc:title>PowerPoint Presentation</dc:title>
</cp:coreProperties>
</file>